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20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718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969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053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116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378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856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552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204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739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8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62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95265-5D7F-4E39-9463-3AFDA0285452}" type="datetimeFigureOut">
              <a:rPr lang="en-US" smtClean="0"/>
              <a:t>1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7ED61-6CD4-4A18-A2E9-1F8AE199E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8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ebaumgardner.NAM\Desktop\New folder\AlignmentPic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03" y="915354"/>
            <a:ext cx="9071500" cy="4987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Connector 4"/>
          <p:cNvCxnSpPr/>
          <p:nvPr/>
        </p:nvCxnSpPr>
        <p:spPr>
          <a:xfrm>
            <a:off x="2130643" y="990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1701554" y="990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330607" y="990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769312" y="99245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900346" y="99245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56102" y="99245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8399756" y="99245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577268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303756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14654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48704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683712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446756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8211844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8575088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9135122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59062" y="24384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8464858" y="2422864"/>
            <a:ext cx="0" cy="381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66946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55234" y="17526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8492971" y="2421754"/>
            <a:ext cx="0" cy="381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8430828" y="2422864"/>
            <a:ext cx="0" cy="381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1407112" y="24384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1357546" y="24384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2357763" y="2431742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5800078" y="24384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7677704" y="242286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8359805" y="2421754"/>
            <a:ext cx="0" cy="381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8656469" y="31242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159062" y="31330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750166" y="313492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1967146" y="313492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394664" y="3126049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7010400" y="313492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8077200" y="3143805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387881" y="313492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1603901" y="313492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159062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1034990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3583620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4208756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4915269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8973844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8111231" y="38684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781800" y="386141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159062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8669044" y="455424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5943600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370034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5114278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373735" y="53010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3710868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22558" y="458494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846556" y="4584947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5257800" y="45720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3765610" y="53010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3678315" y="53010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5585532" y="5292200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8727488" y="5309956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9065579" y="53010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167936" y="5318834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3610254" y="5297378"/>
            <a:ext cx="0" cy="381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88198" y="6019799"/>
            <a:ext cx="81795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Mauve alignment of </a:t>
            </a:r>
            <a:r>
              <a:rPr lang="en-US" sz="1600" dirty="0" err="1" smtClean="0"/>
              <a:t>contigs</a:t>
            </a:r>
            <a:r>
              <a:rPr lang="en-US" sz="1600" dirty="0" smtClean="0"/>
              <a:t> from strains NPL1 through NPL7.  </a:t>
            </a:r>
          </a:p>
          <a:p>
            <a:r>
              <a:rPr lang="en-US" sz="1600" dirty="0" err="1" smtClean="0"/>
              <a:t>Contig</a:t>
            </a:r>
            <a:r>
              <a:rPr lang="en-US" sz="1600" dirty="0" smtClean="0"/>
              <a:t> boundaries are indicated by black lines.  Colored boxes represent Locally Collinear </a:t>
            </a:r>
            <a:r>
              <a:rPr lang="en-US" sz="1600" dirty="0"/>
              <a:t>B</a:t>
            </a:r>
            <a:r>
              <a:rPr lang="en-US" sz="1600" dirty="0" smtClean="0"/>
              <a:t>locks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444186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2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umgardner, Eric AH/US</dc:creator>
  <cp:lastModifiedBy>Baumgardner, Eric AH/US</cp:lastModifiedBy>
  <cp:revision>7</cp:revision>
  <dcterms:created xsi:type="dcterms:W3CDTF">2015-01-02T16:08:01Z</dcterms:created>
  <dcterms:modified xsi:type="dcterms:W3CDTF">2015-01-02T17:07:48Z</dcterms:modified>
</cp:coreProperties>
</file>